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5" d="100"/>
          <a:sy n="75" d="100"/>
        </p:scale>
        <p:origin x="-156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A353B-8ABE-174C-9B03-4918DD7FB5D9}" type="datetimeFigureOut">
              <a:rPr lang="en-US" smtClean="0"/>
              <a:t>1/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03FEF-FB5E-6B47-B1F9-60C020409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440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A353B-8ABE-174C-9B03-4918DD7FB5D9}" type="datetimeFigureOut">
              <a:rPr lang="en-US" smtClean="0"/>
              <a:t>1/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03FEF-FB5E-6B47-B1F9-60C020409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701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A353B-8ABE-174C-9B03-4918DD7FB5D9}" type="datetimeFigureOut">
              <a:rPr lang="en-US" smtClean="0"/>
              <a:t>1/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03FEF-FB5E-6B47-B1F9-60C020409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791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A353B-8ABE-174C-9B03-4918DD7FB5D9}" type="datetimeFigureOut">
              <a:rPr lang="en-US" smtClean="0"/>
              <a:t>1/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03FEF-FB5E-6B47-B1F9-60C020409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183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A353B-8ABE-174C-9B03-4918DD7FB5D9}" type="datetimeFigureOut">
              <a:rPr lang="en-US" smtClean="0"/>
              <a:t>1/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03FEF-FB5E-6B47-B1F9-60C020409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772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A353B-8ABE-174C-9B03-4918DD7FB5D9}" type="datetimeFigureOut">
              <a:rPr lang="en-US" smtClean="0"/>
              <a:t>1/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03FEF-FB5E-6B47-B1F9-60C020409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238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A353B-8ABE-174C-9B03-4918DD7FB5D9}" type="datetimeFigureOut">
              <a:rPr lang="en-US" smtClean="0"/>
              <a:t>1/8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03FEF-FB5E-6B47-B1F9-60C020409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324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A353B-8ABE-174C-9B03-4918DD7FB5D9}" type="datetimeFigureOut">
              <a:rPr lang="en-US" smtClean="0"/>
              <a:t>1/8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03FEF-FB5E-6B47-B1F9-60C020409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128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A353B-8ABE-174C-9B03-4918DD7FB5D9}" type="datetimeFigureOut">
              <a:rPr lang="en-US" smtClean="0"/>
              <a:t>1/8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03FEF-FB5E-6B47-B1F9-60C020409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897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A353B-8ABE-174C-9B03-4918DD7FB5D9}" type="datetimeFigureOut">
              <a:rPr lang="en-US" smtClean="0"/>
              <a:t>1/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03FEF-FB5E-6B47-B1F9-60C020409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470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2A353B-8ABE-174C-9B03-4918DD7FB5D9}" type="datetimeFigureOut">
              <a:rPr lang="en-US" smtClean="0"/>
              <a:t>1/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03FEF-FB5E-6B47-B1F9-60C020409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685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2A353B-8ABE-174C-9B03-4918DD7FB5D9}" type="datetimeFigureOut">
              <a:rPr lang="en-US" smtClean="0"/>
              <a:t>1/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03FEF-FB5E-6B47-B1F9-60C0204097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592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1"/>
          <p:cNvSpPr txBox="1"/>
          <p:nvPr/>
        </p:nvSpPr>
        <p:spPr>
          <a:xfrm>
            <a:off x="324555" y="369332"/>
            <a:ext cx="59350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/>
              <a:t>Table</a:t>
            </a:r>
            <a:r>
              <a:rPr kumimoji="1" lang="en-US" altLang="ja-JP" b="1" dirty="0" smtClean="0"/>
              <a:t> </a:t>
            </a:r>
            <a:r>
              <a:rPr kumimoji="1" lang="en-US" altLang="ja-JP" b="1" dirty="0" smtClean="0"/>
              <a:t>S2. </a:t>
            </a:r>
            <a:r>
              <a:rPr kumimoji="1" lang="en-US" altLang="ja-JP" b="1" dirty="0"/>
              <a:t>L</a:t>
            </a:r>
            <a:r>
              <a:rPr kumimoji="1" lang="en-US" altLang="ja-JP" b="1" dirty="0" smtClean="0"/>
              <a:t>ist of primers used for S1PRs mRNA measurement</a:t>
            </a:r>
            <a:r>
              <a:rPr kumimoji="1" lang="en-US" altLang="ja-JP" b="1" dirty="0" smtClean="0"/>
              <a:t> </a:t>
            </a:r>
            <a:endParaRPr kumimoji="1" lang="ja-JP" altLang="en-US" b="1" dirty="0"/>
          </a:p>
        </p:txBody>
      </p:sp>
      <p:graphicFrame>
        <p:nvGraphicFramePr>
          <p:cNvPr id="7" name="Content Placeholder 6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927842841"/>
              </p:ext>
            </p:extLst>
          </p:nvPr>
        </p:nvGraphicFramePr>
        <p:xfrm>
          <a:off x="936978" y="1662289"/>
          <a:ext cx="6654800" cy="25958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92455"/>
                <a:gridCol w="1654136"/>
                <a:gridCol w="4208209"/>
              </a:tblGrid>
              <a:tr h="370840">
                <a:tc gridSpan="2">
                  <a:txBody>
                    <a:bodyPr/>
                    <a:lstStyle/>
                    <a:p>
                      <a:r>
                        <a:rPr lang="en-US" b="1" dirty="0" smtClean="0"/>
                        <a:t>Gene</a:t>
                      </a:r>
                      <a:endParaRPr lang="en-US" b="1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1" dirty="0" smtClean="0"/>
                        <a:t>Primer sequences</a:t>
                      </a:r>
                      <a:endParaRPr lang="en-US" b="1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</a:tr>
              <a:tr h="370840">
                <a:tc rowSpan="2">
                  <a:txBody>
                    <a:bodyPr/>
                    <a:lstStyle/>
                    <a:p>
                      <a:r>
                        <a:rPr lang="en-US" b="1" dirty="0" smtClean="0"/>
                        <a:t>S1P1</a:t>
                      </a:r>
                      <a:endParaRPr lang="en-US" b="1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b="1" i="1" dirty="0" smtClean="0"/>
                        <a:t>Forward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CCTCTTCCTGCTAATCAGCG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b="1" i="1" dirty="0" smtClean="0"/>
                        <a:t>Reverse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ACAGGTCTTCACCTTGCAGC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 rowSpan="2">
                  <a:txBody>
                    <a:bodyPr/>
                    <a:lstStyle/>
                    <a:p>
                      <a:r>
                        <a:rPr lang="en-US" b="1" dirty="0" smtClean="0"/>
                        <a:t>S1P2</a:t>
                      </a:r>
                      <a:endParaRPr lang="en-US" b="1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b="1" i="1" dirty="0" smtClean="0"/>
                        <a:t>Forward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GCCTAGCCAGTTCTGAAAGC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b="1" i="1" dirty="0" smtClean="0"/>
                        <a:t>Reverse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ACAGGTACATTGCCGAGTGG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 rowSpan="2">
                  <a:txBody>
                    <a:bodyPr/>
                    <a:lstStyle/>
                    <a:p>
                      <a:r>
                        <a:rPr lang="en-US" b="1" dirty="0" smtClean="0"/>
                        <a:t>S1P3</a:t>
                      </a:r>
                      <a:endParaRPr lang="en-US" b="1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b="1" i="1" dirty="0" smtClean="0"/>
                        <a:t>Forward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CGACGGAGGAGCCCTTTTTC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b="1" i="1" dirty="0" smtClean="0"/>
                        <a:t>Reverse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TCCAAAATCCACGAGAGGGC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91472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29</Words>
  <Application>Microsoft Macintosh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UN3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ranbileg Baasanjav</dc:creator>
  <cp:lastModifiedBy>Uranbileg Baasanjav</cp:lastModifiedBy>
  <cp:revision>7</cp:revision>
  <dcterms:created xsi:type="dcterms:W3CDTF">2016-01-08T05:52:02Z</dcterms:created>
  <dcterms:modified xsi:type="dcterms:W3CDTF">2016-01-08T06:54:22Z</dcterms:modified>
</cp:coreProperties>
</file>